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64" r:id="rId2"/>
    <p:sldId id="272" r:id="rId3"/>
    <p:sldId id="267" r:id="rId4"/>
    <p:sldId id="271" r:id="rId5"/>
    <p:sldId id="268" r:id="rId6"/>
    <p:sldId id="270" r:id="rId7"/>
    <p:sldId id="269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55A10"/>
    <a:srgbClr val="A01432"/>
    <a:srgbClr val="2F5497"/>
    <a:srgbClr val="DF4D1C"/>
    <a:srgbClr val="A01533"/>
    <a:srgbClr val="5BE5FF"/>
    <a:srgbClr val="F1E631"/>
    <a:srgbClr val="45DF11"/>
    <a:srgbClr val="9DC3E6"/>
    <a:srgbClr val="F265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78"/>
    <p:restoredTop sz="94947"/>
  </p:normalViewPr>
  <p:slideViewPr>
    <p:cSldViewPr snapToGrid="0">
      <p:cViewPr>
        <p:scale>
          <a:sx n="160" d="100"/>
          <a:sy n="160" d="100"/>
        </p:scale>
        <p:origin x="3080" y="144"/>
      </p:cViewPr>
      <p:guideLst/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7844F1-6E84-6A4F-A06B-1FE1AFB29F75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E14367-E2D4-BB4C-91F9-7418D974B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4314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E14367-E2D4-BB4C-91F9-7418D974BE4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44504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Red </a:t>
            </a:r>
            <a:r>
              <a:rPr lang="en-GB" dirty="0" err="1"/>
              <a:t>dottred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E14367-E2D4-BB4C-91F9-7418D974BE4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8373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E14367-E2D4-BB4C-91F9-7418D974BE4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04978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Red </a:t>
            </a:r>
            <a:r>
              <a:rPr lang="en-GB" dirty="0" err="1"/>
              <a:t>dottred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E14367-E2D4-BB4C-91F9-7418D974BE4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3093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E14367-E2D4-BB4C-91F9-7418D974BE4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0298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Red </a:t>
            </a:r>
            <a:r>
              <a:rPr lang="en-GB" dirty="0" err="1"/>
              <a:t>dottred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E14367-E2D4-BB4C-91F9-7418D974BE4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7201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6082-C3B7-204F-BBE6-1C075A0361DE}" type="datetime1">
              <a:rPr lang="en-GB" smtClean="0"/>
              <a:t>20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118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63479-94C6-7E40-8475-58E8060839DD}" type="datetime1">
              <a:rPr lang="en-GB" smtClean="0"/>
              <a:t>20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522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CDB7D-5F23-AE47-90F1-6515DB302B4E}" type="datetime1">
              <a:rPr lang="en-GB" smtClean="0"/>
              <a:t>20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682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1D8B8-914C-4849-B471-3847115874F2}" type="datetime1">
              <a:rPr lang="en-GB" smtClean="0"/>
              <a:t>20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85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EA5A1-ECE3-6B46-A2E9-A0380714983C}" type="datetime1">
              <a:rPr lang="en-GB" smtClean="0"/>
              <a:t>20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939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4F7E3-974F-B441-9A81-2B380F7F10E3}" type="datetime1">
              <a:rPr lang="en-GB" smtClean="0"/>
              <a:t>20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988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F4252-93B4-9A48-95EA-51F6FDABECCD}" type="datetime1">
              <a:rPr lang="en-GB" smtClean="0"/>
              <a:t>20/0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600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1F7C60-6B1F-9347-8FF4-23287FE71E34}" type="datetime1">
              <a:rPr lang="en-GB" smtClean="0"/>
              <a:t>20/0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94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EEDC3-7CB3-1B47-A47A-0D0CF504AC69}" type="datetime1">
              <a:rPr lang="en-GB" smtClean="0"/>
              <a:t>20/0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489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ACDC1-784C-6C4E-8B80-292F84FB07A0}" type="datetime1">
              <a:rPr lang="en-GB" smtClean="0"/>
              <a:t>20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774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5C33A-8A6B-3B42-A885-68E504ED1FEB}" type="datetime1">
              <a:rPr lang="en-GB" smtClean="0"/>
              <a:t>20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434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96BC4-55DD-9348-A49B-4CC4E338D039}" type="datetime1">
              <a:rPr lang="en-GB" smtClean="0"/>
              <a:t>20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D0241A-213B-0D43-8C5F-E0FAC9CA12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094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I.lidbury@sheffield.ac.uk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png"/><Relationship Id="rId7" Type="http://schemas.openxmlformats.org/officeDocument/2006/relationships/image" Target="../media/image9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3CD7652-D139-1266-7F02-47CF76B1BF9E}"/>
              </a:ext>
            </a:extLst>
          </p:cNvPr>
          <p:cNvSpPr txBox="1"/>
          <p:nvPr/>
        </p:nvSpPr>
        <p:spPr>
          <a:xfrm>
            <a:off x="127542" y="115058"/>
            <a:ext cx="6623115" cy="37317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200"/>
              </a:spcAft>
            </a:pPr>
            <a:r>
              <a:rPr lang="en-GB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ybrid xyloglucan utilisation loci are prevalent among plant-associated Bacteroidota</a:t>
            </a:r>
            <a:endParaRPr lang="en-GB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nnah Martin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+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ucy Rogers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+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ila Moushtaq-Kheradmandi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manda A. Brindley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lly Forbes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my R. Quintion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rew R.J. Murphy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Tim J. Daniell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Didier Ndeh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am Amsbury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rew Hitchcock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2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Ian D.E.A. Lidbury</a:t>
            </a: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 </a:t>
            </a:r>
          </a:p>
          <a:p>
            <a:pPr algn="just">
              <a:lnSpc>
                <a:spcPct val="150000"/>
              </a:lnSpc>
            </a:pP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olecular Microbiology - Biochemistry and Disease, School of Biosciences, The University of Sheffield, Sheffield, UK</a:t>
            </a:r>
          </a:p>
          <a:p>
            <a:pPr algn="just">
              <a:lnSpc>
                <a:spcPct val="150000"/>
              </a:lnSpc>
            </a:pP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lants, Photosynthesis and Soil, School of Biosciences, The University of Sheffield, Sheffield, UK</a:t>
            </a:r>
          </a:p>
          <a:p>
            <a:pPr algn="just">
              <a:lnSpc>
                <a:spcPct val="150000"/>
              </a:lnSpc>
            </a:pP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 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ool of Life Sciences, University of Warwick, Coventry, UK</a:t>
            </a:r>
          </a:p>
          <a:p>
            <a:pPr algn="just">
              <a:lnSpc>
                <a:spcPct val="150000"/>
              </a:lnSpc>
            </a:pP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 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ool of Life Sciences, University of Dundee, Dundee, UK</a:t>
            </a:r>
          </a:p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GB" sz="105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th authors contributed equally to this study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GB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Corresponding author: </a:t>
            </a:r>
            <a:r>
              <a:rPr lang="en-GB" sz="1050" b="1" dirty="0">
                <a:solidFill>
                  <a:srgbClr val="0070C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3"/>
              </a:rPr>
              <a:t>I.lidbury@sheffield.ac.uk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31A029-2CC3-FEAD-98BA-32499C38A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3229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82026A-DB55-72E7-4087-BA71D74E95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2DF9C2-9E54-1AB8-3287-11BDB07DB7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D6C5358-87D3-ADD6-5297-E132AF9C6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2</a:t>
            </a:fld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C8CD92C-60F4-93B5-5E36-93784775176A}"/>
              </a:ext>
            </a:extLst>
          </p:cNvPr>
          <p:cNvSpPr txBox="1"/>
          <p:nvPr/>
        </p:nvSpPr>
        <p:spPr>
          <a:xfrm>
            <a:off x="260565" y="864461"/>
            <a:ext cx="6336869" cy="23314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</a:p>
          <a:p>
            <a:pPr algn="just">
              <a:spcAft>
                <a:spcPts val="600"/>
              </a:spcAft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Phylogenetic reconstruction of Type I and Type II GH5_4 homologs identified in 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Flavobacterium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spp. …….…...…………………………................................................................................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just">
              <a:spcAft>
                <a:spcPts val="600"/>
              </a:spcAft>
            </a:pP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igure S2. Enzyme assays using recombinant BoGH5A incubated with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XyG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…..……………….…………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 algn="just">
              <a:spcAft>
                <a:spcPts val="600"/>
              </a:spcAft>
            </a:pP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igure S3. The molecular basis of protein-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XyG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binding by BoGH5A …………....………………………….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just">
              <a:spcAft>
                <a:spcPts val="600"/>
              </a:spcAft>
            </a:pP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igure S4. Phylogenetic reconstruction of the identified GH5_4 homologs found in the genomes of terrestrial Bacteroidota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spp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…………………………………………………………….……….…………..…….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just">
              <a:spcAft>
                <a:spcPts val="600"/>
              </a:spcAft>
            </a:pP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igure S5. Distribution of GH5_4 homologs in Flavobacterium soil and plant metagenomes…………….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just">
              <a:spcAft>
                <a:spcPts val="600"/>
              </a:spcAft>
            </a:pP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DFD5AB-7CA4-7A33-4B87-FA6B342EA54A}"/>
              </a:ext>
            </a:extLst>
          </p:cNvPr>
          <p:cNvSpPr txBox="1"/>
          <p:nvPr/>
        </p:nvSpPr>
        <p:spPr>
          <a:xfrm>
            <a:off x="260565" y="3110898"/>
            <a:ext cx="6336869" cy="22544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s (see separate excel file)</a:t>
            </a:r>
          </a:p>
          <a:p>
            <a:pPr algn="just">
              <a:spcAft>
                <a:spcPts val="600"/>
              </a:spcAft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List of primers used in this study </a:t>
            </a:r>
          </a:p>
          <a:p>
            <a:pPr algn="just">
              <a:spcAft>
                <a:spcPts val="600"/>
              </a:spcAft>
            </a:pP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able S2. Details of the isolates genomes deposited in IMG/JGI that were scrutinised in this study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able S3. Details of the soil/plant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metgenomes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deposited in IMG/JGI that were scrutinised in this study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able S4. Comparative whole-cell proteomics of 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Flavobacterium johnsoniae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DSM2064 (UW101) grown on xyloglucan or glucose. Data files were generated using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MaxQuant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and Perseus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able S5. Comparative whole-cell proteomics of 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Flavobacterium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sp.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OSR005 grown on xyloglucan or glucose. Data files were generated using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MaxQuant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and Perseus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C4D9A2-E2C4-57DB-FE3B-E9FD99266F3B}"/>
              </a:ext>
            </a:extLst>
          </p:cNvPr>
          <p:cNvSpPr txBox="1"/>
          <p:nvPr/>
        </p:nvSpPr>
        <p:spPr>
          <a:xfrm>
            <a:off x="260565" y="311236"/>
            <a:ext cx="22210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tents</a:t>
            </a:r>
          </a:p>
        </p:txBody>
      </p:sp>
    </p:spTree>
    <p:extLst>
      <p:ext uri="{BB962C8B-B14F-4D97-AF65-F5344CB8AC3E}">
        <p14:creationId xmlns:p14="http://schemas.microsoft.com/office/powerpoint/2010/main" val="8866330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DE2E010-BC13-037A-F020-B5EFB40F712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55226"/>
          <a:stretch/>
        </p:blipFill>
        <p:spPr>
          <a:xfrm>
            <a:off x="619613" y="1129247"/>
            <a:ext cx="5571068" cy="709338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D4CDE0F-5952-30F1-9165-049455C3BCDE}"/>
              </a:ext>
            </a:extLst>
          </p:cNvPr>
          <p:cNvSpPr txBox="1"/>
          <p:nvPr/>
        </p:nvSpPr>
        <p:spPr>
          <a:xfrm>
            <a:off x="172278" y="8498994"/>
            <a:ext cx="6490915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. Phylogenetic reconstruction of Type I and Type II GH5_4 homologs identified in </a:t>
            </a:r>
            <a:r>
              <a:rPr lang="en-GB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Flavobacterium 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pp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opology was inferred using the maximum-likelihood consensus method (bootstrap = 1000), and the most appropriate parsimony model was selected using IQTREE. Previously characterised homologs from 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C. japonicus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(red dotted line)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GB" sz="1050" i="1" dirty="0" err="1">
                <a:latin typeface="Arial" panose="020B0604020202020204" pitchFamily="34" charset="0"/>
                <a:cs typeface="Arial" panose="020B0604020202020204" pitchFamily="34" charset="0"/>
              </a:rPr>
              <a:t>ovatus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showing the variable Trp252 residue (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Bo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GH5A) and either adjacent amino acid.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E17697C2-3138-015A-83B5-49D005A78403}"/>
              </a:ext>
            </a:extLst>
          </p:cNvPr>
          <p:cNvCxnSpPr/>
          <p:nvPr/>
        </p:nvCxnSpPr>
        <p:spPr>
          <a:xfrm>
            <a:off x="5020456" y="1869474"/>
            <a:ext cx="0" cy="430471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623512EA-3A71-B45E-FFE1-C8064A91A17B}"/>
              </a:ext>
            </a:extLst>
          </p:cNvPr>
          <p:cNvCxnSpPr>
            <a:cxnSpLocks/>
          </p:cNvCxnSpPr>
          <p:nvPr/>
        </p:nvCxnSpPr>
        <p:spPr>
          <a:xfrm>
            <a:off x="5020456" y="6214213"/>
            <a:ext cx="0" cy="182394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E56A7D9F-3C5E-61E1-431D-213275DBB8E6}"/>
              </a:ext>
            </a:extLst>
          </p:cNvPr>
          <p:cNvSpPr txBox="1"/>
          <p:nvPr/>
        </p:nvSpPr>
        <p:spPr>
          <a:xfrm>
            <a:off x="4246223" y="3844199"/>
            <a:ext cx="813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Type 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2F57692-8B9C-AFEC-0FB6-88F37280BF05}"/>
              </a:ext>
            </a:extLst>
          </p:cNvPr>
          <p:cNvSpPr txBox="1"/>
          <p:nvPr/>
        </p:nvSpPr>
        <p:spPr>
          <a:xfrm>
            <a:off x="4207348" y="6877463"/>
            <a:ext cx="877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Type II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2DAF99-25D5-CD4D-545A-1D1144546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68804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1CA1D0D-79A9-E167-EC77-05B7DDEE87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4338" y="5779220"/>
            <a:ext cx="2789323" cy="251560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BE8C4BA-C838-6346-BEEB-26EA35072F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44765" y="3111845"/>
            <a:ext cx="2997870" cy="253515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0F6F82D-1243-0323-548B-28BF4B5ED2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70922" y="451423"/>
            <a:ext cx="2952250" cy="252212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E92EC42-9B93-66D9-1A2C-0D6EBC7BFFE1}"/>
              </a:ext>
            </a:extLst>
          </p:cNvPr>
          <p:cNvSpPr txBox="1"/>
          <p:nvPr/>
        </p:nvSpPr>
        <p:spPr>
          <a:xfrm>
            <a:off x="222639" y="8452676"/>
            <a:ext cx="648031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2. Enzyme assays using recombinant BoGH5A incubated with 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XyG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Initial enzyme reaction velocity of 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Bo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GH4A wild type and mutants were quantified using reducing sugar assays (DNSA) (n=3) against an increasing concentration of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XyG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. For mutants, higher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conentrations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of enzyme were used in order to accurately quantify the initial velocity (</a:t>
            </a:r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GB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F90CD57-DFB9-18D6-22E3-01472427B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5922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659CCDD-3492-7E6A-1F70-63E9CB10B19A}"/>
              </a:ext>
            </a:extLst>
          </p:cNvPr>
          <p:cNvSpPr txBox="1"/>
          <p:nvPr/>
        </p:nvSpPr>
        <p:spPr>
          <a:xfrm>
            <a:off x="174929" y="8499109"/>
            <a:ext cx="6567776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3. The molecular basis of protein-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XyG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binding by BoGH5A.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lecular interactions between BoGH5A and </a:t>
            </a:r>
            <a:r>
              <a:rPr lang="en-GB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XyG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the third xylose side branch found in a typical XXXG motif </a:t>
            </a:r>
            <a:r>
              <a:rPr lang="en-GB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including those occurring with Trp252 (green dashes). Interactions were calculated using Arpeggio that is available for use on the </a:t>
            </a:r>
            <a:r>
              <a:rPr lang="en-GB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DBe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b server, using the carbohydrate polymer function in ligand and environment. c) The cleft (0-4 subsites) of </a:t>
            </a:r>
            <a:r>
              <a:rPr lang="en-GB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XyG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specific and promiscuous GH5_4 enzymes  with </a:t>
            </a:r>
            <a:r>
              <a:rPr lang="en-GB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XyG</a:t>
            </a:r>
            <a:r>
              <a:rPr lang="en-GB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ligosaccharide modelled. 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close-up of a molecule&#10;&#10;Description automatically generated with low confidence">
            <a:extLst>
              <a:ext uri="{FF2B5EF4-FFF2-40B4-BE49-F238E27FC236}">
                <a16:creationId xmlns:a16="http://schemas.microsoft.com/office/drawing/2014/main" id="{042E3C6C-0D2B-90A7-F36E-8FA4D1E57DE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45"/>
          <a:stretch/>
        </p:blipFill>
        <p:spPr>
          <a:xfrm>
            <a:off x="687216" y="3716821"/>
            <a:ext cx="2351587" cy="2132741"/>
          </a:xfrm>
          <a:prstGeom prst="rect">
            <a:avLst/>
          </a:prstGeom>
        </p:spPr>
      </p:pic>
      <p:pic>
        <p:nvPicPr>
          <p:cNvPr id="6" name="Picture 5" descr="A picture containing colorfulness, light&#10;&#10;Description automatically generated">
            <a:extLst>
              <a:ext uri="{FF2B5EF4-FFF2-40B4-BE49-F238E27FC236}">
                <a16:creationId xmlns:a16="http://schemas.microsoft.com/office/drawing/2014/main" id="{C009D834-30A3-A504-9446-BFFF3F69274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045"/>
          <a:stretch/>
        </p:blipFill>
        <p:spPr>
          <a:xfrm>
            <a:off x="3974927" y="3716822"/>
            <a:ext cx="2351587" cy="213274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6CB269E-76F6-8872-927A-2807E71BD209}"/>
              </a:ext>
            </a:extLst>
          </p:cNvPr>
          <p:cNvSpPr txBox="1"/>
          <p:nvPr/>
        </p:nvSpPr>
        <p:spPr>
          <a:xfrm>
            <a:off x="1484629" y="3509435"/>
            <a:ext cx="6399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B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GH5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3108DE-F4C5-3D6D-CB78-657E4C43FE23}"/>
              </a:ext>
            </a:extLst>
          </p:cNvPr>
          <p:cNvSpPr txBox="1"/>
          <p:nvPr/>
        </p:nvSpPr>
        <p:spPr>
          <a:xfrm>
            <a:off x="4853202" y="3509435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Cj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GH5d</a:t>
            </a:r>
          </a:p>
        </p:txBody>
      </p:sp>
      <p:pic>
        <p:nvPicPr>
          <p:cNvPr id="10" name="Picture 9" descr="A close-up of a molecule&#10;&#10;Description automatically generated">
            <a:extLst>
              <a:ext uri="{FF2B5EF4-FFF2-40B4-BE49-F238E27FC236}">
                <a16:creationId xmlns:a16="http://schemas.microsoft.com/office/drawing/2014/main" id="{727FAA37-ABB5-A16E-BFBD-850A91B52DD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174" r="1772"/>
          <a:stretch/>
        </p:blipFill>
        <p:spPr>
          <a:xfrm>
            <a:off x="698664" y="6034954"/>
            <a:ext cx="2330652" cy="218037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0A11CE8-DFD5-664D-0077-D885C358805F}"/>
              </a:ext>
            </a:extLst>
          </p:cNvPr>
          <p:cNvSpPr txBox="1"/>
          <p:nvPr/>
        </p:nvSpPr>
        <p:spPr>
          <a:xfrm>
            <a:off x="1415142" y="5843293"/>
            <a:ext cx="627095" cy="408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ae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GH5</a:t>
            </a:r>
          </a:p>
        </p:txBody>
      </p:sp>
      <p:pic>
        <p:nvPicPr>
          <p:cNvPr id="12" name="Picture 11" descr="A close-up of a structure&#10;&#10;Description automatically generated">
            <a:extLst>
              <a:ext uri="{FF2B5EF4-FFF2-40B4-BE49-F238E27FC236}">
                <a16:creationId xmlns:a16="http://schemas.microsoft.com/office/drawing/2014/main" id="{D1916A25-88B5-B1F0-B5A5-0BB743848EC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776"/>
          <a:stretch/>
        </p:blipFill>
        <p:spPr>
          <a:xfrm>
            <a:off x="3967727" y="6027147"/>
            <a:ext cx="2368743" cy="218818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605380C-6554-2B18-FC05-C015268E7795}"/>
              </a:ext>
            </a:extLst>
          </p:cNvPr>
          <p:cNvSpPr txBox="1"/>
          <p:nvPr/>
        </p:nvSpPr>
        <p:spPr>
          <a:xfrm>
            <a:off x="4853202" y="5831217"/>
            <a:ext cx="562975" cy="408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rj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GH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F5C8100-74A5-85A6-7655-0B3B1E05159F}"/>
              </a:ext>
            </a:extLst>
          </p:cNvPr>
          <p:cNvSpPr txBox="1"/>
          <p:nvPr/>
        </p:nvSpPr>
        <p:spPr>
          <a:xfrm rot="16200000">
            <a:off x="12237" y="4667775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XyG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-specific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4EA2744-E913-3136-DBE7-A9CE7EBCA5CD}"/>
              </a:ext>
            </a:extLst>
          </p:cNvPr>
          <p:cNvSpPr txBox="1"/>
          <p:nvPr/>
        </p:nvSpPr>
        <p:spPr>
          <a:xfrm rot="16200000">
            <a:off x="-4307" y="7005823"/>
            <a:ext cx="8515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romiscuous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1F62A7C-F4EE-EB66-9A20-366C429297A2}"/>
              </a:ext>
            </a:extLst>
          </p:cNvPr>
          <p:cNvCxnSpPr>
            <a:cxnSpLocks/>
          </p:cNvCxnSpPr>
          <p:nvPr/>
        </p:nvCxnSpPr>
        <p:spPr>
          <a:xfrm>
            <a:off x="546321" y="3716821"/>
            <a:ext cx="0" cy="213274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79625056-FB5E-2F20-7A97-59AD5F02E4D4}"/>
              </a:ext>
            </a:extLst>
          </p:cNvPr>
          <p:cNvSpPr txBox="1"/>
          <p:nvPr/>
        </p:nvSpPr>
        <p:spPr>
          <a:xfrm>
            <a:off x="53304" y="572982"/>
            <a:ext cx="3097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FAC551B-D5C0-7EA4-C3A6-C7B709D4ED8D}"/>
              </a:ext>
            </a:extLst>
          </p:cNvPr>
          <p:cNvSpPr txBox="1"/>
          <p:nvPr/>
        </p:nvSpPr>
        <p:spPr>
          <a:xfrm>
            <a:off x="2612436" y="572982"/>
            <a:ext cx="4168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140110FB-A580-3943-9D66-A6984353E02F}"/>
              </a:ext>
            </a:extLst>
          </p:cNvPr>
          <p:cNvCxnSpPr>
            <a:cxnSpLocks/>
          </p:cNvCxnSpPr>
          <p:nvPr/>
        </p:nvCxnSpPr>
        <p:spPr>
          <a:xfrm flipV="1">
            <a:off x="536866" y="6042884"/>
            <a:ext cx="0" cy="217244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8" name="Picture 27">
            <a:extLst>
              <a:ext uri="{FF2B5EF4-FFF2-40B4-BE49-F238E27FC236}">
                <a16:creationId xmlns:a16="http://schemas.microsoft.com/office/drawing/2014/main" id="{8D55B117-03C2-88AC-DE0F-CCBF4425D45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1545" r="12136" b="23568"/>
          <a:stretch/>
        </p:blipFill>
        <p:spPr>
          <a:xfrm>
            <a:off x="3660507" y="533258"/>
            <a:ext cx="2801212" cy="2805367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D83779E6-955F-5782-63C6-D3560A3093D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0630" t="4350" r="16749" b="22105"/>
          <a:stretch/>
        </p:blipFill>
        <p:spPr>
          <a:xfrm>
            <a:off x="566991" y="567929"/>
            <a:ext cx="2665516" cy="269941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57CB5332-0058-DFA3-2410-5F6226BC10E8}"/>
              </a:ext>
            </a:extLst>
          </p:cNvPr>
          <p:cNvSpPr txBox="1"/>
          <p:nvPr/>
        </p:nvSpPr>
        <p:spPr>
          <a:xfrm>
            <a:off x="3347183" y="572982"/>
            <a:ext cx="3097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30D9F62-6E55-759B-E407-38E6677F1BC6}"/>
              </a:ext>
            </a:extLst>
          </p:cNvPr>
          <p:cNvSpPr txBox="1"/>
          <p:nvPr/>
        </p:nvSpPr>
        <p:spPr>
          <a:xfrm>
            <a:off x="133124" y="3455210"/>
            <a:ext cx="3016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1F98B5-1098-96AA-F7A6-BE72D2EF8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2638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48AEF89-45ED-1512-751F-68FDFFC8B4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9816" y="585579"/>
            <a:ext cx="5623542" cy="5623542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333E19EE-4EAF-EED1-2240-42BF58FD65B9}"/>
              </a:ext>
            </a:extLst>
          </p:cNvPr>
          <p:cNvSpPr>
            <a:spLocks noChangeAspect="1"/>
          </p:cNvSpPr>
          <p:nvPr/>
        </p:nvSpPr>
        <p:spPr>
          <a:xfrm>
            <a:off x="1658357" y="6503167"/>
            <a:ext cx="106535" cy="108000"/>
          </a:xfrm>
          <a:prstGeom prst="rect">
            <a:avLst/>
          </a:prstGeom>
          <a:solidFill>
            <a:srgbClr val="E06666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2E76085-7F07-6399-1C3D-D5EC4E521A20}"/>
              </a:ext>
            </a:extLst>
          </p:cNvPr>
          <p:cNvSpPr>
            <a:spLocks noChangeAspect="1"/>
          </p:cNvSpPr>
          <p:nvPr/>
        </p:nvSpPr>
        <p:spPr>
          <a:xfrm>
            <a:off x="1658357" y="6665687"/>
            <a:ext cx="106535" cy="108000"/>
          </a:xfrm>
          <a:prstGeom prst="rect">
            <a:avLst/>
          </a:prstGeom>
          <a:solidFill>
            <a:srgbClr val="5B9BD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1734BF1-41E6-99F2-7D97-FEF41B02DCDF}"/>
              </a:ext>
            </a:extLst>
          </p:cNvPr>
          <p:cNvSpPr>
            <a:spLocks noChangeAspect="1"/>
          </p:cNvSpPr>
          <p:nvPr/>
        </p:nvSpPr>
        <p:spPr>
          <a:xfrm>
            <a:off x="1658357" y="6835077"/>
            <a:ext cx="106535" cy="108000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653514E-DA3E-8609-346A-1F10823407D9}"/>
              </a:ext>
            </a:extLst>
          </p:cNvPr>
          <p:cNvSpPr txBox="1"/>
          <p:nvPr/>
        </p:nvSpPr>
        <p:spPr>
          <a:xfrm>
            <a:off x="1711101" y="6457281"/>
            <a:ext cx="6367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Cytophagia</a:t>
            </a:r>
            <a:endParaRPr 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0F0FC77-EF18-9BEC-7F4F-3A3CC95CFA99}"/>
              </a:ext>
            </a:extLst>
          </p:cNvPr>
          <p:cNvSpPr txBox="1"/>
          <p:nvPr/>
        </p:nvSpPr>
        <p:spPr>
          <a:xfrm>
            <a:off x="2572616" y="6458453"/>
            <a:ext cx="7409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Flavobacteriia</a:t>
            </a:r>
            <a:endParaRPr 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9C1E960-D76F-D76D-C9CB-538091DA7B02}"/>
              </a:ext>
            </a:extLst>
          </p:cNvPr>
          <p:cNvSpPr txBox="1"/>
          <p:nvPr/>
        </p:nvSpPr>
        <p:spPr>
          <a:xfrm>
            <a:off x="1707687" y="6617797"/>
            <a:ext cx="8499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Sphingobacteriia</a:t>
            </a:r>
            <a:endParaRPr 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AD0B3B2-353A-1B8D-CAD4-04983163E21C}"/>
              </a:ext>
            </a:extLst>
          </p:cNvPr>
          <p:cNvSpPr>
            <a:spLocks noChangeAspect="1"/>
          </p:cNvSpPr>
          <p:nvPr/>
        </p:nvSpPr>
        <p:spPr>
          <a:xfrm>
            <a:off x="2519872" y="6494782"/>
            <a:ext cx="106535" cy="108000"/>
          </a:xfrm>
          <a:prstGeom prst="rect">
            <a:avLst/>
          </a:prstGeom>
          <a:solidFill>
            <a:srgbClr val="6AA84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4FCD918-19DA-6F21-44CD-C2D4F85E9D7D}"/>
              </a:ext>
            </a:extLst>
          </p:cNvPr>
          <p:cNvSpPr txBox="1"/>
          <p:nvPr/>
        </p:nvSpPr>
        <p:spPr>
          <a:xfrm>
            <a:off x="1711101" y="6786533"/>
            <a:ext cx="72968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Chitinophagia</a:t>
            </a:r>
            <a:endParaRPr 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7284788-AF29-7C21-D4A6-6D5C2F3836D9}"/>
              </a:ext>
            </a:extLst>
          </p:cNvPr>
          <p:cNvSpPr>
            <a:spLocks noChangeAspect="1"/>
          </p:cNvSpPr>
          <p:nvPr/>
        </p:nvSpPr>
        <p:spPr>
          <a:xfrm>
            <a:off x="2518135" y="6659211"/>
            <a:ext cx="106535" cy="108000"/>
          </a:xfrm>
          <a:prstGeom prst="rect">
            <a:avLst/>
          </a:prstGeom>
          <a:solidFill>
            <a:srgbClr val="09529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93DE6AD-72E2-ED04-E3B1-9678D185DAE2}"/>
              </a:ext>
            </a:extLst>
          </p:cNvPr>
          <p:cNvSpPr txBox="1"/>
          <p:nvPr/>
        </p:nvSpPr>
        <p:spPr>
          <a:xfrm>
            <a:off x="2572187" y="6619087"/>
            <a:ext cx="64312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Pedobacter</a:t>
            </a:r>
            <a:endParaRPr 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58050E4-0860-01F7-8316-2660122E30B4}"/>
              </a:ext>
            </a:extLst>
          </p:cNvPr>
          <p:cNvSpPr>
            <a:spLocks noChangeAspect="1"/>
          </p:cNvSpPr>
          <p:nvPr/>
        </p:nvSpPr>
        <p:spPr>
          <a:xfrm>
            <a:off x="3236108" y="6512599"/>
            <a:ext cx="106535" cy="108000"/>
          </a:xfrm>
          <a:prstGeom prst="rect">
            <a:avLst/>
          </a:prstGeom>
          <a:solidFill>
            <a:srgbClr val="C27B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A25FCA7-F2CC-F2BE-5CE6-57D587DE7675}"/>
              </a:ext>
            </a:extLst>
          </p:cNvPr>
          <p:cNvSpPr txBox="1"/>
          <p:nvPr/>
        </p:nvSpPr>
        <p:spPr>
          <a:xfrm>
            <a:off x="3282540" y="6472475"/>
            <a:ext cx="55976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ovatus</a:t>
            </a:r>
            <a:endParaRPr 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CBDC1C4-5C91-1B15-F106-E9F730F9EFCE}"/>
              </a:ext>
            </a:extLst>
          </p:cNvPr>
          <p:cNvSpPr>
            <a:spLocks noChangeAspect="1"/>
          </p:cNvSpPr>
          <p:nvPr/>
        </p:nvSpPr>
        <p:spPr>
          <a:xfrm>
            <a:off x="3236108" y="6665521"/>
            <a:ext cx="106535" cy="108000"/>
          </a:xfrm>
          <a:prstGeom prst="rect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7F5765C-C457-013C-3E6F-0CC8125C1690}"/>
              </a:ext>
            </a:extLst>
          </p:cNvPr>
          <p:cNvSpPr txBox="1"/>
          <p:nvPr/>
        </p:nvSpPr>
        <p:spPr>
          <a:xfrm>
            <a:off x="3282540" y="6625946"/>
            <a:ext cx="6960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ubclade 2C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892993CA-B097-38CC-C8AB-F2B3AC65BF6E}"/>
              </a:ext>
            </a:extLst>
          </p:cNvPr>
          <p:cNvCxnSpPr>
            <a:cxnSpLocks/>
          </p:cNvCxnSpPr>
          <p:nvPr/>
        </p:nvCxnSpPr>
        <p:spPr>
          <a:xfrm flipV="1">
            <a:off x="4168388" y="6669446"/>
            <a:ext cx="5413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5C84E18-8B62-1B0C-C102-B700348B20E2}"/>
              </a:ext>
            </a:extLst>
          </p:cNvPr>
          <p:cNvCxnSpPr>
            <a:cxnSpLocks/>
          </p:cNvCxnSpPr>
          <p:nvPr/>
        </p:nvCxnSpPr>
        <p:spPr>
          <a:xfrm flipV="1">
            <a:off x="4776516" y="6673858"/>
            <a:ext cx="541379" cy="0"/>
          </a:xfrm>
          <a:prstGeom prst="line">
            <a:avLst/>
          </a:prstGeom>
          <a:ln w="952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BD94F7E-2DBF-7B8D-36F2-4867A4D7044D}"/>
              </a:ext>
            </a:extLst>
          </p:cNvPr>
          <p:cNvCxnSpPr>
            <a:cxnSpLocks/>
          </p:cNvCxnSpPr>
          <p:nvPr/>
        </p:nvCxnSpPr>
        <p:spPr>
          <a:xfrm flipV="1">
            <a:off x="4776517" y="6727896"/>
            <a:ext cx="541379" cy="0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38E4CCD1-2AD2-68B7-E1B5-5B7FDE082BA4}"/>
              </a:ext>
            </a:extLst>
          </p:cNvPr>
          <p:cNvCxnSpPr>
            <a:cxnSpLocks/>
          </p:cNvCxnSpPr>
          <p:nvPr/>
        </p:nvCxnSpPr>
        <p:spPr>
          <a:xfrm flipV="1">
            <a:off x="4776516" y="6787260"/>
            <a:ext cx="541379" cy="0"/>
          </a:xfrm>
          <a:prstGeom prst="line">
            <a:avLst/>
          </a:prstGeom>
          <a:ln w="9525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2D51E803-955C-DD5E-890F-C06F3D9431CB}"/>
              </a:ext>
            </a:extLst>
          </p:cNvPr>
          <p:cNvSpPr txBox="1"/>
          <p:nvPr/>
        </p:nvSpPr>
        <p:spPr>
          <a:xfrm>
            <a:off x="4097364" y="6457690"/>
            <a:ext cx="6479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 homolog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C04510-E062-699E-7E10-26BDDCFFC444}"/>
              </a:ext>
            </a:extLst>
          </p:cNvPr>
          <p:cNvSpPr txBox="1"/>
          <p:nvPr/>
        </p:nvSpPr>
        <p:spPr>
          <a:xfrm>
            <a:off x="4679918" y="6457690"/>
            <a:ext cx="7120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0" i="0" dirty="0">
                <a:solidFill>
                  <a:srgbClr val="20212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≥3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homologs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96C22AE9-3578-6756-7C0D-AF572013C5B7}"/>
              </a:ext>
            </a:extLst>
          </p:cNvPr>
          <p:cNvCxnSpPr>
            <a:cxnSpLocks/>
          </p:cNvCxnSpPr>
          <p:nvPr/>
        </p:nvCxnSpPr>
        <p:spPr>
          <a:xfrm flipV="1">
            <a:off x="4776516" y="6835097"/>
            <a:ext cx="541379" cy="0"/>
          </a:xfrm>
          <a:prstGeom prst="line">
            <a:avLst/>
          </a:prstGeom>
          <a:ln w="9525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9BC8A52A-5B87-8F20-266F-158699975EC5}"/>
              </a:ext>
            </a:extLst>
          </p:cNvPr>
          <p:cNvSpPr txBox="1"/>
          <p:nvPr/>
        </p:nvSpPr>
        <p:spPr>
          <a:xfrm>
            <a:off x="1566057" y="6316238"/>
            <a:ext cx="6030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Taxonomy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3DA739A-CF1F-7E6E-97C1-FB9D49C70751}"/>
              </a:ext>
            </a:extLst>
          </p:cNvPr>
          <p:cNvSpPr txBox="1"/>
          <p:nvPr/>
        </p:nvSpPr>
        <p:spPr>
          <a:xfrm>
            <a:off x="4086785" y="6319023"/>
            <a:ext cx="5421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Linkage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751CA85-ACAC-10B5-4896-1095665A75AE}"/>
              </a:ext>
            </a:extLst>
          </p:cNvPr>
          <p:cNvSpPr txBox="1"/>
          <p:nvPr/>
        </p:nvSpPr>
        <p:spPr>
          <a:xfrm>
            <a:off x="151074" y="7293761"/>
            <a:ext cx="6619673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4. Phylogenetic reconstruction of the identified GH5_4 homologs found in the genomes of terrestrial Bacteroidota spp. </a:t>
            </a:r>
            <a:r>
              <a:rPr lang="en-GB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pology was inferred using the maximum-likelihood consensus method (bootstrap = 1000), and the most appropriate parsimony model was selected using IQTREE. Linkages between </a:t>
            </a:r>
            <a:r>
              <a:rPr lang="en-GB" sz="105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</a:t>
            </a:r>
            <a:r>
              <a:rPr lang="en-GB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mologs identified from the same genome depicted by the inverted CICRUS plot. </a:t>
            </a:r>
            <a:r>
              <a:rPr lang="en-GB" sz="105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</a:t>
            </a:r>
            <a:r>
              <a:rPr lang="en-GB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re linkages were omitted for clarity, </a:t>
            </a:r>
            <a:r>
              <a:rPr lang="en-GB" sz="105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GB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ck dots denote cases where a single homolog is present in the genome (i.e. </a:t>
            </a:r>
            <a:r>
              <a:rPr lang="en-GB" sz="105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. johnsoniae</a:t>
            </a:r>
            <a:r>
              <a:rPr lang="en-GB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whilst white dots denote </a:t>
            </a:r>
            <a:r>
              <a:rPr lang="en-GB" sz="105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omologs where </a:t>
            </a:r>
            <a:r>
              <a:rPr lang="en-GB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ltiple forms were identified in one genome (i.e</a:t>
            </a:r>
            <a:r>
              <a:rPr lang="en-GB" sz="105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, OSR005)</a:t>
            </a:r>
            <a:r>
              <a:rPr lang="en-GB" sz="10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Note that some genomes contain up to seven GH5_4 homologs. Linkage colours and tree branches correspond to a specific taxonomic classification (see legend) and dashed or dotted linkages represent three or more homologs identified within a single genome.</a:t>
            </a:r>
            <a:r>
              <a:rPr lang="en-GB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ere are no instances were GH5_4 homologs carrying the Ala or </a:t>
            </a:r>
            <a:r>
              <a:rPr lang="en-GB" sz="105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y</a:t>
            </a:r>
            <a:r>
              <a:rPr lang="en-GB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sidue were the single homology in a genome. 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2735996D-69C4-32A3-0332-34859B56A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345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659CCDD-3492-7E6A-1F70-63E9CB10B19A}"/>
              </a:ext>
            </a:extLst>
          </p:cNvPr>
          <p:cNvSpPr txBox="1"/>
          <p:nvPr/>
        </p:nvSpPr>
        <p:spPr>
          <a:xfrm>
            <a:off x="2118360" y="43095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S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E2013A8-37C1-13B1-8DBD-FF12F644D6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523" t="12495" r="10584" b="6833"/>
          <a:stretch/>
        </p:blipFill>
        <p:spPr>
          <a:xfrm>
            <a:off x="1977646" y="502543"/>
            <a:ext cx="2648441" cy="254419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A103384-E7CD-48B7-5B5F-F0C8DD7E51A4}"/>
              </a:ext>
            </a:extLst>
          </p:cNvPr>
          <p:cNvSpPr txBox="1"/>
          <p:nvPr/>
        </p:nvSpPr>
        <p:spPr>
          <a:xfrm>
            <a:off x="2309398" y="377451"/>
            <a:ext cx="489537" cy="2005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hylu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37FBE8B-F45C-B642-0E5B-70367AB876CC}"/>
              </a:ext>
            </a:extLst>
          </p:cNvPr>
          <p:cNvSpPr txBox="1"/>
          <p:nvPr/>
        </p:nvSpPr>
        <p:spPr>
          <a:xfrm>
            <a:off x="2830164" y="377988"/>
            <a:ext cx="4131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las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DC19B2D-AD91-8B2A-470E-E93492B99995}"/>
              </a:ext>
            </a:extLst>
          </p:cNvPr>
          <p:cNvSpPr txBox="1"/>
          <p:nvPr/>
        </p:nvSpPr>
        <p:spPr>
          <a:xfrm>
            <a:off x="3323980" y="377451"/>
            <a:ext cx="421275" cy="2005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Orde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8F48062-D26C-65AB-2AD2-3BB8DBC52F22}"/>
              </a:ext>
            </a:extLst>
          </p:cNvPr>
          <p:cNvSpPr txBox="1"/>
          <p:nvPr/>
        </p:nvSpPr>
        <p:spPr>
          <a:xfrm>
            <a:off x="3804184" y="377451"/>
            <a:ext cx="453780" cy="2005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Famil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8A3FD5-116A-7FBE-EE18-6FFDEA70E55E}"/>
              </a:ext>
            </a:extLst>
          </p:cNvPr>
          <p:cNvSpPr txBox="1"/>
          <p:nvPr/>
        </p:nvSpPr>
        <p:spPr>
          <a:xfrm>
            <a:off x="4295716" y="377451"/>
            <a:ext cx="455407" cy="2005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Genu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6D30EB7-C7BC-CF63-A6E1-2AD4FC9D643F}"/>
              </a:ext>
            </a:extLst>
          </p:cNvPr>
          <p:cNvSpPr txBox="1"/>
          <p:nvPr/>
        </p:nvSpPr>
        <p:spPr>
          <a:xfrm>
            <a:off x="1812165" y="377451"/>
            <a:ext cx="544798" cy="2005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Kingdo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CFBD243-EDEA-D26F-B8AB-3FC6449CE9D8}"/>
              </a:ext>
            </a:extLst>
          </p:cNvPr>
          <p:cNvSpPr txBox="1"/>
          <p:nvPr/>
        </p:nvSpPr>
        <p:spPr>
          <a:xfrm>
            <a:off x="4505771" y="1495470"/>
            <a:ext cx="8080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Flavobacteriu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6ADFF74-DE98-3A82-8756-96FA0C59C2B9}"/>
              </a:ext>
            </a:extLst>
          </p:cNvPr>
          <p:cNvSpPr txBox="1"/>
          <p:nvPr/>
        </p:nvSpPr>
        <p:spPr>
          <a:xfrm>
            <a:off x="4511830" y="2443117"/>
            <a:ext cx="557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Cellvibrio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F984FC-3342-B933-A4C7-E00AFD2E66B0}"/>
              </a:ext>
            </a:extLst>
          </p:cNvPr>
          <p:cNvSpPr txBox="1"/>
          <p:nvPr/>
        </p:nvSpPr>
        <p:spPr>
          <a:xfrm>
            <a:off x="4505771" y="1709063"/>
            <a:ext cx="82272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Mucilangibacter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306BA57-EE29-ABDC-DA4E-A3FEA160440E}"/>
              </a:ext>
            </a:extLst>
          </p:cNvPr>
          <p:cNvSpPr txBox="1"/>
          <p:nvPr/>
        </p:nvSpPr>
        <p:spPr>
          <a:xfrm>
            <a:off x="4511830" y="1294434"/>
            <a:ext cx="7203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Chitinophaga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1CBDFBC-38C7-0B0B-ED32-C651E3669EA7}"/>
              </a:ext>
            </a:extLst>
          </p:cNvPr>
          <p:cNvSpPr txBox="1"/>
          <p:nvPr/>
        </p:nvSpPr>
        <p:spPr>
          <a:xfrm>
            <a:off x="4511830" y="781815"/>
            <a:ext cx="7609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Capsilomonas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7239DCB-3DA0-28D4-05C8-19E20AA416B4}"/>
              </a:ext>
            </a:extLst>
          </p:cNvPr>
          <p:cNvSpPr txBox="1"/>
          <p:nvPr/>
        </p:nvSpPr>
        <p:spPr>
          <a:xfrm rot="16200000">
            <a:off x="2247932" y="1537348"/>
            <a:ext cx="5435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cteroidota</a:t>
            </a:r>
            <a:endParaRPr lang="en-US" sz="5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547C637-7056-00C3-31FF-EFD6D92F8534}"/>
              </a:ext>
            </a:extLst>
          </p:cNvPr>
          <p:cNvSpPr txBox="1"/>
          <p:nvPr/>
        </p:nvSpPr>
        <p:spPr>
          <a:xfrm rot="16200000">
            <a:off x="1811764" y="1654995"/>
            <a:ext cx="46965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i="1" dirty="0">
                <a:latin typeface="Arial" panose="020B0604020202020204" pitchFamily="34" charset="0"/>
                <a:cs typeface="Arial" panose="020B0604020202020204" pitchFamily="34" charset="0"/>
              </a:rPr>
              <a:t>Bacteri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472F49A-C9FA-C80B-5969-FE1D73B523E4}"/>
              </a:ext>
            </a:extLst>
          </p:cNvPr>
          <p:cNvSpPr txBox="1"/>
          <p:nvPr/>
        </p:nvSpPr>
        <p:spPr>
          <a:xfrm rot="16200000">
            <a:off x="2176343" y="2145277"/>
            <a:ext cx="68503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eudomonadota</a:t>
            </a:r>
            <a:endParaRPr lang="en-US" sz="5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965CE91-68D2-73FD-2875-0C256D86E6A0}"/>
              </a:ext>
            </a:extLst>
          </p:cNvPr>
          <p:cNvSpPr/>
          <p:nvPr/>
        </p:nvSpPr>
        <p:spPr>
          <a:xfrm>
            <a:off x="1993044" y="3254618"/>
            <a:ext cx="2811173" cy="76682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FCD35B7-3F1C-33B4-5BED-EF7CBB20DEA5}"/>
              </a:ext>
            </a:extLst>
          </p:cNvPr>
          <p:cNvSpPr txBox="1"/>
          <p:nvPr/>
        </p:nvSpPr>
        <p:spPr>
          <a:xfrm rot="16200000">
            <a:off x="2337940" y="960461"/>
            <a:ext cx="3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o</a:t>
            </a:r>
            <a:endParaRPr lang="en-US" sz="5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F01AC17-1E96-264B-860B-95B68F7DA3A9}"/>
              </a:ext>
            </a:extLst>
          </p:cNvPr>
          <p:cNvSpPr>
            <a:spLocks noChangeAspect="1"/>
          </p:cNvSpPr>
          <p:nvPr/>
        </p:nvSpPr>
        <p:spPr>
          <a:xfrm>
            <a:off x="2073869" y="3577503"/>
            <a:ext cx="106536" cy="108000"/>
          </a:xfrm>
          <a:prstGeom prst="rect">
            <a:avLst/>
          </a:prstGeom>
          <a:solidFill>
            <a:srgbClr val="F65C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7B825B5-8B2A-3DCA-AA99-D5871501CF90}"/>
              </a:ext>
            </a:extLst>
          </p:cNvPr>
          <p:cNvSpPr>
            <a:spLocks noChangeAspect="1"/>
          </p:cNvSpPr>
          <p:nvPr/>
        </p:nvSpPr>
        <p:spPr>
          <a:xfrm>
            <a:off x="2073869" y="3725055"/>
            <a:ext cx="106536" cy="108000"/>
          </a:xfrm>
          <a:prstGeom prst="rect">
            <a:avLst/>
          </a:prstGeom>
          <a:solidFill>
            <a:srgbClr val="F5855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7656A577-DED3-DBE6-0AD1-A485E5E80D99}"/>
              </a:ext>
            </a:extLst>
          </p:cNvPr>
          <p:cNvSpPr>
            <a:spLocks noChangeAspect="1"/>
          </p:cNvSpPr>
          <p:nvPr/>
        </p:nvSpPr>
        <p:spPr>
          <a:xfrm>
            <a:off x="2073869" y="3438221"/>
            <a:ext cx="106536" cy="108000"/>
          </a:xfrm>
          <a:prstGeom prst="rect">
            <a:avLst/>
          </a:prstGeom>
          <a:solidFill>
            <a:srgbClr val="99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386A5B8-3BCA-CFE3-2998-2F8D6B79E6BF}"/>
              </a:ext>
            </a:extLst>
          </p:cNvPr>
          <p:cNvSpPr>
            <a:spLocks noChangeAspect="1"/>
          </p:cNvSpPr>
          <p:nvPr/>
        </p:nvSpPr>
        <p:spPr>
          <a:xfrm>
            <a:off x="2978867" y="3437951"/>
            <a:ext cx="106536" cy="108000"/>
          </a:xfrm>
          <a:prstGeom prst="rect">
            <a:avLst/>
          </a:prstGeom>
          <a:solidFill>
            <a:srgbClr val="12810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788F6F63-2A91-4D2A-F78D-391721B464DE}"/>
              </a:ext>
            </a:extLst>
          </p:cNvPr>
          <p:cNvSpPr>
            <a:spLocks noChangeAspect="1"/>
          </p:cNvSpPr>
          <p:nvPr/>
        </p:nvSpPr>
        <p:spPr>
          <a:xfrm>
            <a:off x="2978867" y="3577961"/>
            <a:ext cx="106536" cy="108000"/>
          </a:xfrm>
          <a:prstGeom prst="rect">
            <a:avLst/>
          </a:prstGeom>
          <a:solidFill>
            <a:srgbClr val="8FCE0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0B4E590-5237-924B-1242-AA390AB69F8B}"/>
              </a:ext>
            </a:extLst>
          </p:cNvPr>
          <p:cNvSpPr txBox="1"/>
          <p:nvPr/>
        </p:nvSpPr>
        <p:spPr>
          <a:xfrm>
            <a:off x="2137453" y="3677637"/>
            <a:ext cx="56297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Betaproteo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1C914B1-E756-C354-B5C6-79E0AFEAF52C}"/>
              </a:ext>
            </a:extLst>
          </p:cNvPr>
          <p:cNvSpPr txBox="1"/>
          <p:nvPr/>
        </p:nvSpPr>
        <p:spPr>
          <a:xfrm>
            <a:off x="2137453" y="3535786"/>
            <a:ext cx="67839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Gammaproteo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0DEF4DE-453C-F843-DB23-D7B69233BE31}"/>
              </a:ext>
            </a:extLst>
          </p:cNvPr>
          <p:cNvSpPr txBox="1"/>
          <p:nvPr/>
        </p:nvSpPr>
        <p:spPr>
          <a:xfrm>
            <a:off x="3042451" y="3685710"/>
            <a:ext cx="6671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Flavobacteriia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AEE2FEE-C509-A58E-B7EF-B06652C51598}"/>
              </a:ext>
            </a:extLst>
          </p:cNvPr>
          <p:cNvSpPr txBox="1"/>
          <p:nvPr/>
        </p:nvSpPr>
        <p:spPr>
          <a:xfrm>
            <a:off x="3042134" y="3386894"/>
            <a:ext cx="76335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Sphingobacteriia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036F269C-5ACE-0EA2-EC8E-87F473378B5D}"/>
              </a:ext>
            </a:extLst>
          </p:cNvPr>
          <p:cNvSpPr>
            <a:spLocks noChangeAspect="1"/>
          </p:cNvSpPr>
          <p:nvPr/>
        </p:nvSpPr>
        <p:spPr>
          <a:xfrm>
            <a:off x="2978867" y="3725656"/>
            <a:ext cx="106536" cy="108000"/>
          </a:xfrm>
          <a:prstGeom prst="rect">
            <a:avLst/>
          </a:prstGeom>
          <a:solidFill>
            <a:srgbClr val="6AA84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097FF21-9F94-72E8-B6DA-4B3A92948269}"/>
              </a:ext>
            </a:extLst>
          </p:cNvPr>
          <p:cNvSpPr txBox="1"/>
          <p:nvPr/>
        </p:nvSpPr>
        <p:spPr>
          <a:xfrm>
            <a:off x="3042451" y="3527641"/>
            <a:ext cx="6607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Chitinophagia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12D33EA-5499-7056-0F51-160E8F81E709}"/>
              </a:ext>
            </a:extLst>
          </p:cNvPr>
          <p:cNvSpPr txBox="1"/>
          <p:nvPr/>
        </p:nvSpPr>
        <p:spPr>
          <a:xfrm>
            <a:off x="2146794" y="3393244"/>
            <a:ext cx="6030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Alphaproteo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6CC4819-4932-C85C-7753-F1E9EF1AC04B}"/>
              </a:ext>
            </a:extLst>
          </p:cNvPr>
          <p:cNvSpPr>
            <a:spLocks noChangeAspect="1"/>
          </p:cNvSpPr>
          <p:nvPr/>
        </p:nvSpPr>
        <p:spPr>
          <a:xfrm>
            <a:off x="3988780" y="3584404"/>
            <a:ext cx="105389" cy="108000"/>
          </a:xfrm>
          <a:prstGeom prst="rect">
            <a:avLst/>
          </a:prstGeom>
          <a:solidFill>
            <a:srgbClr val="7789D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1D80F25-9289-2A68-8B9D-F1ED74B50541}"/>
              </a:ext>
            </a:extLst>
          </p:cNvPr>
          <p:cNvSpPr txBox="1"/>
          <p:nvPr/>
        </p:nvSpPr>
        <p:spPr>
          <a:xfrm>
            <a:off x="4047671" y="3552034"/>
            <a:ext cx="4780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Bacillota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9EE05E2-9BD4-44F7-FB47-DBCE01CD2A5C}"/>
              </a:ext>
            </a:extLst>
          </p:cNvPr>
          <p:cNvSpPr>
            <a:spLocks noChangeAspect="1"/>
          </p:cNvSpPr>
          <p:nvPr/>
        </p:nvSpPr>
        <p:spPr>
          <a:xfrm>
            <a:off x="3988206" y="3724613"/>
            <a:ext cx="106536" cy="108000"/>
          </a:xfrm>
          <a:prstGeom prst="rect">
            <a:avLst/>
          </a:prstGeom>
          <a:solidFill>
            <a:srgbClr val="2B46FA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04EF452-7BFE-5DC4-E82B-B62F3A35E7E9}"/>
              </a:ext>
            </a:extLst>
          </p:cNvPr>
          <p:cNvSpPr txBox="1"/>
          <p:nvPr/>
        </p:nvSpPr>
        <p:spPr>
          <a:xfrm>
            <a:off x="4042922" y="3678884"/>
            <a:ext cx="7553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Planctomycetota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F50D8EF-FC74-60E1-024E-CBF1A9D42FB1}"/>
              </a:ext>
            </a:extLst>
          </p:cNvPr>
          <p:cNvSpPr>
            <a:spLocks noChangeAspect="1"/>
          </p:cNvSpPr>
          <p:nvPr/>
        </p:nvSpPr>
        <p:spPr>
          <a:xfrm>
            <a:off x="2073869" y="3858702"/>
            <a:ext cx="106536" cy="108000"/>
          </a:xfrm>
          <a:prstGeom prst="rect">
            <a:avLst/>
          </a:prstGeom>
          <a:solidFill>
            <a:srgbClr val="F5855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4072D0B-7D17-3988-366C-88069D687A36}"/>
              </a:ext>
            </a:extLst>
          </p:cNvPr>
          <p:cNvSpPr txBox="1"/>
          <p:nvPr/>
        </p:nvSpPr>
        <p:spPr>
          <a:xfrm>
            <a:off x="2134278" y="3808109"/>
            <a:ext cx="58541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Deltaproteo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FE04817F-227F-CFB5-4B23-7DB2EC3BB734}"/>
              </a:ext>
            </a:extLst>
          </p:cNvPr>
          <p:cNvSpPr>
            <a:spLocks noChangeAspect="1"/>
          </p:cNvSpPr>
          <p:nvPr/>
        </p:nvSpPr>
        <p:spPr>
          <a:xfrm>
            <a:off x="3988780" y="3865873"/>
            <a:ext cx="105389" cy="108000"/>
          </a:xfrm>
          <a:prstGeom prst="rect">
            <a:avLst/>
          </a:prstGeom>
          <a:solidFill>
            <a:srgbClr val="7789D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8522210-1F45-1F2E-3224-2C663A3E79C8}"/>
              </a:ext>
            </a:extLst>
          </p:cNvPr>
          <p:cNvSpPr txBox="1"/>
          <p:nvPr/>
        </p:nvSpPr>
        <p:spPr>
          <a:xfrm>
            <a:off x="4042153" y="3812734"/>
            <a:ext cx="7120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Actinomycetota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CAE0E9A0-FC6F-A039-12E5-E4537E6542AD}"/>
              </a:ext>
            </a:extLst>
          </p:cNvPr>
          <p:cNvSpPr>
            <a:spLocks noChangeAspect="1"/>
          </p:cNvSpPr>
          <p:nvPr/>
        </p:nvSpPr>
        <p:spPr>
          <a:xfrm>
            <a:off x="3988780" y="3443449"/>
            <a:ext cx="105389" cy="108000"/>
          </a:xfrm>
          <a:prstGeom prst="rect">
            <a:avLst/>
          </a:prstGeom>
          <a:solidFill>
            <a:srgbClr val="7789D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23E71E3-F56B-44BC-C216-94DBA0EF31E2}"/>
              </a:ext>
            </a:extLst>
          </p:cNvPr>
          <p:cNvSpPr txBox="1"/>
          <p:nvPr/>
        </p:nvSpPr>
        <p:spPr>
          <a:xfrm>
            <a:off x="4047671" y="3401554"/>
            <a:ext cx="75212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Armatimonadota</a:t>
            </a:r>
            <a:endParaRPr 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281A02E-BE75-FCE0-CCB5-0C29A7B95213}"/>
              </a:ext>
            </a:extLst>
          </p:cNvPr>
          <p:cNvSpPr txBox="1"/>
          <p:nvPr/>
        </p:nvSpPr>
        <p:spPr>
          <a:xfrm>
            <a:off x="1981044" y="3235568"/>
            <a:ext cx="5453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u="sng" dirty="0">
                <a:latin typeface="Arial" panose="020B0604020202020204" pitchFamily="34" charset="0"/>
                <a:cs typeface="Arial" panose="020B0604020202020204" pitchFamily="34" charset="0"/>
              </a:rPr>
              <a:t>Taxonomy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0560BDD3-1F00-18CA-A193-5FAA02233E3D}"/>
              </a:ext>
            </a:extLst>
          </p:cNvPr>
          <p:cNvSpPr/>
          <p:nvPr/>
        </p:nvSpPr>
        <p:spPr>
          <a:xfrm>
            <a:off x="1931569" y="2884736"/>
            <a:ext cx="241028" cy="1965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1488E8D-2F0C-71A9-4CC6-2F9B2977325B}"/>
              </a:ext>
            </a:extLst>
          </p:cNvPr>
          <p:cNvSpPr txBox="1"/>
          <p:nvPr/>
        </p:nvSpPr>
        <p:spPr>
          <a:xfrm>
            <a:off x="135173" y="4308617"/>
            <a:ext cx="660402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5. Distribution of GH5_4 homologs in </a:t>
            </a:r>
            <a:r>
              <a:rPr lang="en-GB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Flavobacterium 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oil and plant metagenomes.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Taxonomic classification and relative abundance of ORFs retrieved from metagenomes categorised as soil rhizosphere, root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endosphere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or surrounding bulk soil, deposited in IMG/JG. ORFs were BLAST against the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CAZYdb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050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211BDDC-62D3-FB11-2477-125177C6D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0241A-213B-0D43-8C5F-E0FAC9CA120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511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296</TotalTime>
  <Words>870</Words>
  <Application>Microsoft Macintosh PowerPoint</Application>
  <PresentationFormat>A4 Paper (210x297 mm)</PresentationFormat>
  <Paragraphs>99</Paragraphs>
  <Slides>7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Lidbury</dc:creator>
  <cp:lastModifiedBy>Ian Lidbury</cp:lastModifiedBy>
  <cp:revision>200</cp:revision>
  <cp:lastPrinted>2024-05-20T10:15:30Z</cp:lastPrinted>
  <dcterms:created xsi:type="dcterms:W3CDTF">2022-10-13T12:47:54Z</dcterms:created>
  <dcterms:modified xsi:type="dcterms:W3CDTF">2024-05-20T10:52:44Z</dcterms:modified>
</cp:coreProperties>
</file>